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22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927D1EA-AFEE-9BCF-7D51-18C8EEB1F8C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52CFEC43-3601-780B-C1BB-DB45F992748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F86A75A-2F59-1849-AFD6-DCD63498C6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0E170-400E-4FA3-B846-1EFFA48B9BCE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12B464E-631A-8C7C-2322-E21AA37BE8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F20C455-F692-A77F-82D5-4C5DB8E88D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110EB-C1F7-44EA-B383-4E9A3711847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89622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208E552-0D68-8F83-CE3B-6364BBD8D0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6D6F6C9E-C09F-65A2-9176-A89A29D72FF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0A948A3-88D2-A421-6A25-63CEBE6216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0E170-400E-4FA3-B846-1EFFA48B9BCE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EF60AE7-1278-8FF2-B3E2-461E59996F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503529A-3167-11B8-B329-7BB20E2045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110EB-C1F7-44EA-B383-4E9A3711847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99537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2FF5F665-48DD-AF0B-F432-441BB468F83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9F7F3457-570F-EEFC-1292-E670832172A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89869F0-320A-CE0A-28DE-F41EC87680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0E170-400E-4FA3-B846-1EFFA48B9BCE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7F5E72A-246B-18F7-C12B-C024B526FB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07D80DC-BC47-E85A-5588-629BFEA89B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110EB-C1F7-44EA-B383-4E9A3711847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65860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12B6717-AD27-B7C4-21C9-C7409EBB8A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6A225F4C-15C2-D66D-89F3-BDAB2589C98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2502196-32CF-C8D9-E346-DDDC78AA70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0E170-400E-4FA3-B846-1EFFA48B9BCE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C5D2F3B-A046-FA91-0ECE-BA3103B7D4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07CDB96-132E-A12E-D2CF-59235EE990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110EB-C1F7-44EA-B383-4E9A3711847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82212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07C789B-565A-3E06-AFC0-0318293885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B6393A54-BAF1-77B7-42F0-7377D9C18A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53BC74A-5DD0-5486-2D0E-6EDBA74A39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0E170-400E-4FA3-B846-1EFFA48B9BCE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4A4B9F6-035F-5531-51B7-4F3F9E4938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28C4BA8-6E8B-A488-BED6-E849BFDA40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110EB-C1F7-44EA-B383-4E9A3711847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55100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56B426D-24CE-3980-E9EA-71C8F01B2E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75AC92EE-0D10-AD8A-B81D-927F2A1E3E9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BAC9BE73-E899-DA92-F1FB-65F7BCC4CA3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7F4D4865-FA52-A58D-19BF-48222562BB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0E170-400E-4FA3-B846-1EFFA48B9BCE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E1AFB3E7-6ECD-7B71-31D6-439362C5E2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5568E23F-14D6-4FDF-D5F2-F76BDE518B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110EB-C1F7-44EA-B383-4E9A3711847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86096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7314CF2-BE5F-CEC2-734D-7A6F6E7F1B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F645897E-5076-5FBC-5014-03325E8655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862B3463-BD13-94D9-82B7-C7BBDF13323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21E70F4C-8E82-B035-91F8-AFD26FBE71B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E1F7B2C8-9A0E-0117-EA31-F82BE200D4F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FBACCB4A-E39B-5FFD-23ED-4FEE059C00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0E170-400E-4FA3-B846-1EFFA48B9BCE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790C3677-546E-10BE-FBAB-A4870146C1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9462FACC-80FD-BE2C-5C1E-DB0F1040E4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110EB-C1F7-44EA-B383-4E9A3711847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91247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A81EA71-0165-14ED-68F3-8FBFD64F80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39FF4F48-E8E2-3C2C-E01B-5530BFDBC9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0E170-400E-4FA3-B846-1EFFA48B9BCE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1FA92BD8-7141-4642-07F0-89D08B8580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E4DA4E56-39D0-0F67-51D2-AFF17E017D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110EB-C1F7-44EA-B383-4E9A3711847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31248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4460A6CD-6AE6-012A-03AC-C5F7ED0333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0E170-400E-4FA3-B846-1EFFA48B9BCE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06EC0508-A329-73A3-39EC-FD49D7B366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FB815950-2A58-C956-8C8A-93922FF6BD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110EB-C1F7-44EA-B383-4E9A3711847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90380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B5202D4-5179-F243-4125-7D1E5EF78B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474A527B-9D90-B947-3730-B6810B95D8A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083A0808-0CBB-D8B7-6B00-A1849C8639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FDB98191-081F-A763-7276-120A60AF76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0E170-400E-4FA3-B846-1EFFA48B9BCE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5BDC369D-05C5-921D-4EF4-8A4D3B64C3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9A438590-E545-A9DE-A434-9F8C28942A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110EB-C1F7-44EA-B383-4E9A3711847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37906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8EF4FCD-AB59-C62D-9055-F88FAFCD00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147F6037-68F7-F77E-2649-1F3B4A18C3B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0665525D-7F27-2711-569F-A991D09454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CABEAC82-5379-1497-08A9-CDED472144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0E170-400E-4FA3-B846-1EFFA48B9BCE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C9A95E56-3052-5E47-1AE4-6A9DD18E55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BBFD94CF-C4C5-7D3F-5B74-26FCEF4CC9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110EB-C1F7-44EA-B383-4E9A3711847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59694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7C4CEBAF-AD18-D49F-A586-330AB1E23C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39923296-FC22-0DD9-F17C-176AA47530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013AC06-5B41-F0F4-0627-E9423A73EFF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C0E170-400E-4FA3-B846-1EFFA48B9BCE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BD5F042-932F-9F14-FEC5-31837A00FDC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8F83565-BFAD-CF60-37E2-BEE7AFC4BD5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6110EB-C1F7-44EA-B383-4E9A3711847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99108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CuadroTexto 9">
            <a:extLst>
              <a:ext uri="{FF2B5EF4-FFF2-40B4-BE49-F238E27FC236}">
                <a16:creationId xmlns:a16="http://schemas.microsoft.com/office/drawing/2014/main" id="{71368F14-8AFB-E7C7-5D79-487DC8F156A7}"/>
              </a:ext>
            </a:extLst>
          </p:cNvPr>
          <p:cNvSpPr txBox="1"/>
          <p:nvPr/>
        </p:nvSpPr>
        <p:spPr>
          <a:xfrm>
            <a:off x="871716" y="5146260"/>
            <a:ext cx="65590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1. Fig.  Size of lesions in relation to: A) type of mycetoma, B) color of grains and C) time of evolution</a:t>
            </a:r>
          </a:p>
        </p:txBody>
      </p:sp>
      <p:grpSp>
        <p:nvGrpSpPr>
          <p:cNvPr id="16" name="Grupo 15">
            <a:extLst>
              <a:ext uri="{FF2B5EF4-FFF2-40B4-BE49-F238E27FC236}">
                <a16:creationId xmlns:a16="http://schemas.microsoft.com/office/drawing/2014/main" id="{375221AF-B077-349A-535C-54D4B7417849}"/>
              </a:ext>
            </a:extLst>
          </p:cNvPr>
          <p:cNvGrpSpPr/>
          <p:nvPr/>
        </p:nvGrpSpPr>
        <p:grpSpPr>
          <a:xfrm>
            <a:off x="722449" y="1630670"/>
            <a:ext cx="3785037" cy="2830368"/>
            <a:chOff x="722449" y="1630670"/>
            <a:chExt cx="3785037" cy="2830368"/>
          </a:xfrm>
        </p:grpSpPr>
        <p:pic>
          <p:nvPicPr>
            <p:cNvPr id="7" name="Imagen 6">
              <a:extLst>
                <a:ext uri="{FF2B5EF4-FFF2-40B4-BE49-F238E27FC236}">
                  <a16:creationId xmlns:a16="http://schemas.microsoft.com/office/drawing/2014/main" id="{06A74628-37FE-CEAB-83D8-B27B7ABF4D5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92236" y="1630670"/>
              <a:ext cx="3715250" cy="2830368"/>
            </a:xfrm>
            <a:prstGeom prst="rect">
              <a:avLst/>
            </a:prstGeom>
          </p:spPr>
        </p:pic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1EB942B5-7B64-8CAD-BC7D-00CDC9CF558B}"/>
                </a:ext>
              </a:extLst>
            </p:cNvPr>
            <p:cNvSpPr txBox="1"/>
            <p:nvPr/>
          </p:nvSpPr>
          <p:spPr>
            <a:xfrm>
              <a:off x="722449" y="1776135"/>
              <a:ext cx="26517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/>
                <a:t>A</a:t>
              </a:r>
            </a:p>
          </p:txBody>
        </p:sp>
      </p:grpSp>
      <p:grpSp>
        <p:nvGrpSpPr>
          <p:cNvPr id="15" name="Grupo 14">
            <a:extLst>
              <a:ext uri="{FF2B5EF4-FFF2-40B4-BE49-F238E27FC236}">
                <a16:creationId xmlns:a16="http://schemas.microsoft.com/office/drawing/2014/main" id="{335BBCA2-4F35-8A40-0F70-84938E7A8362}"/>
              </a:ext>
            </a:extLst>
          </p:cNvPr>
          <p:cNvGrpSpPr/>
          <p:nvPr/>
        </p:nvGrpSpPr>
        <p:grpSpPr>
          <a:xfrm>
            <a:off x="4287011" y="1711740"/>
            <a:ext cx="3449191" cy="2749298"/>
            <a:chOff x="4287011" y="1711740"/>
            <a:chExt cx="3449191" cy="2749298"/>
          </a:xfrm>
        </p:grpSpPr>
        <p:pic>
          <p:nvPicPr>
            <p:cNvPr id="9" name="Imagen 8">
              <a:extLst>
                <a:ext uri="{FF2B5EF4-FFF2-40B4-BE49-F238E27FC236}">
                  <a16:creationId xmlns:a16="http://schemas.microsoft.com/office/drawing/2014/main" id="{C6A677C7-BF4D-99D1-8058-F5B763339E2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426939" y="1711740"/>
              <a:ext cx="3309263" cy="2749298"/>
            </a:xfrm>
            <a:prstGeom prst="rect">
              <a:avLst/>
            </a:prstGeom>
          </p:spPr>
        </p:pic>
        <p:sp>
          <p:nvSpPr>
            <p:cNvPr id="12" name="CuadroTexto 11">
              <a:extLst>
                <a:ext uri="{FF2B5EF4-FFF2-40B4-BE49-F238E27FC236}">
                  <a16:creationId xmlns:a16="http://schemas.microsoft.com/office/drawing/2014/main" id="{778FE3D6-C30F-858B-48CE-3FE176529C21}"/>
                </a:ext>
              </a:extLst>
            </p:cNvPr>
            <p:cNvSpPr txBox="1"/>
            <p:nvPr/>
          </p:nvSpPr>
          <p:spPr>
            <a:xfrm>
              <a:off x="4287011" y="1776136"/>
              <a:ext cx="26517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/>
                <a:t>B</a:t>
              </a:r>
            </a:p>
          </p:txBody>
        </p:sp>
      </p:grpSp>
      <p:grpSp>
        <p:nvGrpSpPr>
          <p:cNvPr id="14" name="Grupo 13">
            <a:extLst>
              <a:ext uri="{FF2B5EF4-FFF2-40B4-BE49-F238E27FC236}">
                <a16:creationId xmlns:a16="http://schemas.microsoft.com/office/drawing/2014/main" id="{EEA1922D-BBD8-3071-2524-2626BD4FE382}"/>
              </a:ext>
            </a:extLst>
          </p:cNvPr>
          <p:cNvGrpSpPr/>
          <p:nvPr/>
        </p:nvGrpSpPr>
        <p:grpSpPr>
          <a:xfrm>
            <a:off x="7904988" y="1711740"/>
            <a:ext cx="3627795" cy="2834502"/>
            <a:chOff x="7904988" y="1711740"/>
            <a:chExt cx="3627795" cy="2834502"/>
          </a:xfrm>
        </p:grpSpPr>
        <p:pic>
          <p:nvPicPr>
            <p:cNvPr id="5" name="Imagen 4">
              <a:extLst>
                <a:ext uri="{FF2B5EF4-FFF2-40B4-BE49-F238E27FC236}">
                  <a16:creationId xmlns:a16="http://schemas.microsoft.com/office/drawing/2014/main" id="{764726EF-B057-3527-AA92-9624613676C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913235" y="1711740"/>
              <a:ext cx="3619548" cy="2834502"/>
            </a:xfrm>
            <a:prstGeom prst="rect">
              <a:avLst/>
            </a:prstGeom>
          </p:spPr>
        </p:pic>
        <p:sp>
          <p:nvSpPr>
            <p:cNvPr id="13" name="CuadroTexto 12">
              <a:extLst>
                <a:ext uri="{FF2B5EF4-FFF2-40B4-BE49-F238E27FC236}">
                  <a16:creationId xmlns:a16="http://schemas.microsoft.com/office/drawing/2014/main" id="{B14890DF-A72A-497A-7296-45A2DA7DDCD9}"/>
                </a:ext>
              </a:extLst>
            </p:cNvPr>
            <p:cNvSpPr txBox="1"/>
            <p:nvPr/>
          </p:nvSpPr>
          <p:spPr>
            <a:xfrm>
              <a:off x="7904988" y="1776136"/>
              <a:ext cx="26517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/>
                <a:t>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54329315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31</Words>
  <Application>Microsoft Office PowerPoint</Application>
  <PresentationFormat>Panorámica</PresentationFormat>
  <Paragraphs>4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olom Valiente, Maria Francisca</dc:creator>
  <cp:lastModifiedBy>Colom Valiente, Maria Francisca</cp:lastModifiedBy>
  <cp:revision>2</cp:revision>
  <dcterms:created xsi:type="dcterms:W3CDTF">2023-04-21T09:48:24Z</dcterms:created>
  <dcterms:modified xsi:type="dcterms:W3CDTF">2023-07-26T10:13:44Z</dcterms:modified>
</cp:coreProperties>
</file>